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D39ED1A-C783-4ECF-A50B-471F18F0A810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8E83EC9-086D-47FA-A9B0-5D077990E5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935C2BA-C71B-4B40-9025-676B7BA019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B70827E-7DDF-4117-9A4B-9C924870466F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3939EF9-383A-488C-B4E9-DE399E8669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9842169-5AD4-47C1-8AFC-E9AAEBB097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CEC717F-70D5-48C5-8AC5-A9C4A4EE8C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EFB3C8C-6009-4892-BCAD-0E02B2B4AE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192AA73-D2B9-44D8-895D-940F77AFF5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25A2C0F-FA83-4FC9-A320-475255AD9E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95F20D7-5913-4415-B4DD-C9C22DE08E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BDC9FDC-2E8B-4E35-93DB-E2F1A5E1C7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 fontScale="96000"/>
          </a:bodyPr>
          <a:p>
            <a:pPr marL="32904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7200" y="6356160"/>
            <a:ext cx="213192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6/5/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6552720" y="6356160"/>
            <a:ext cx="213228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176A999C-C3A5-46F1-ABA2-E6EAAFB1DCD7}" type="slidenum">
              <a:rPr b="0" lang="en-US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17440" y="1851120"/>
          <a:ext cx="8706960" cy="3020760"/>
        </p:xfrm>
        <a:graphic>
          <a:graphicData uri="http://schemas.openxmlformats.org/drawingml/2006/table">
            <a:tbl>
              <a:tblPr/>
              <a:tblGrid>
                <a:gridCol w="1938960"/>
                <a:gridCol w="801720"/>
                <a:gridCol w="796320"/>
                <a:gridCol w="979200"/>
                <a:gridCol w="761760"/>
                <a:gridCol w="871200"/>
                <a:gridCol w="815400"/>
                <a:gridCol w="925200"/>
                <a:gridCol w="817200"/>
              </a:tblGrid>
              <a:tr h="477720">
                <a:tc rowSpan="2"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Usual Language</a:t>
                      </a: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65160" rIns="65160" tIns="32400" bIns="324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991</a:t>
                      </a: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5160" marR="651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996</a:t>
                      </a: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001</a:t>
                      </a: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006</a:t>
                      </a: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85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Numbe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% of total</a:t>
                      </a:r>
                      <a:r>
                        <a:rPr b="0" lang="en-US" sz="1400" spc="-1" strike="noStrike">
                          <a:solidFill>
                            <a:srgbClr val="376092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Numbe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% of total</a:t>
                      </a:r>
                      <a:r>
                        <a:rPr b="0" lang="en-US" sz="1400" spc="-1" strike="noStrike">
                          <a:solidFill>
                            <a:srgbClr val="376092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Numbe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% of total</a:t>
                      </a:r>
                      <a:r>
                        <a:rPr b="0" lang="en-US" sz="1400" spc="-1" strike="noStrike">
                          <a:solidFill>
                            <a:srgbClr val="376092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Numbe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% of total</a:t>
                      </a:r>
                      <a:r>
                        <a:rPr b="0" lang="en-US" sz="1400" spc="-1" strike="noStrike">
                          <a:solidFill>
                            <a:srgbClr val="376092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5100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antonese</a:t>
                      </a:r>
                      <a:r>
                        <a:rPr b="0" lang="en-US" sz="1400" spc="-1" strike="noStrike">
                          <a:solidFill>
                            <a:srgbClr val="f1597a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 583 322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88.7</a:t>
                      </a:r>
                      <a:r>
                        <a:rPr b="0" lang="en-US" sz="1400" spc="-1" strike="noStrike">
                          <a:solidFill>
                            <a:srgbClr val="f1597a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 196 240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88.7</a:t>
                      </a:r>
                      <a:r>
                        <a:rPr b="0" lang="en-US" sz="1400" spc="-1" strike="noStrike">
                          <a:solidFill>
                            <a:srgbClr val="f1597a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 726 972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89.2</a:t>
                      </a:r>
                      <a:r>
                        <a:rPr b="0" lang="en-US" sz="1400" spc="-1" strike="noStrike">
                          <a:solidFill>
                            <a:srgbClr val="f1597a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 030 960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90.8</a:t>
                      </a:r>
                      <a:r>
                        <a:rPr b="0" lang="en-US" sz="1400" spc="-1" strike="noStrike">
                          <a:solidFill>
                            <a:srgbClr val="f1597a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1752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Putonghua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7 577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.1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5 892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.1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5 410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0.9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0 859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0.9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1752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Other Chinese Dialects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64 694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7.1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40 222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.8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52 562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.5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89 027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.4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1752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English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14 084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.2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84 308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.1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03 598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.2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87 281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.8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9664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Others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9 232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.0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73 879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.3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79 197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.2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72 217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.1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5712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Total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 168 909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0.0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 860 541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0.0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 417 739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0.0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 640 344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0.0</a:t>
                      </a:r>
                      <a:r>
                        <a:rPr b="0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1169280" y="1190520"/>
            <a:ext cx="716724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PMingLiU"/>
              </a:rPr>
              <a:t>Table S1 Population in Hong Kong aged 5 and over by usual language, 1991, 1996, 2001 and 2006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557440" y="490680"/>
            <a:ext cx="4408560" cy="34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dditional fi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1861200" y="382680"/>
            <a:ext cx="558396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PMingLiU"/>
              </a:rPr>
              <a:t>Table S2 Population by nationality in Hong Kong 1991, 1996, 2001 and 200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120600" y="932040"/>
          <a:ext cx="8946720" cy="4984560"/>
        </p:xfrm>
        <a:graphic>
          <a:graphicData uri="http://schemas.openxmlformats.org/drawingml/2006/table">
            <a:tbl>
              <a:tblPr/>
              <a:tblGrid>
                <a:gridCol w="3080520"/>
                <a:gridCol w="761760"/>
                <a:gridCol w="571680"/>
                <a:gridCol w="876240"/>
                <a:gridCol w="615600"/>
                <a:gridCol w="907920"/>
                <a:gridCol w="582120"/>
                <a:gridCol w="941400"/>
                <a:gridCol w="609480"/>
              </a:tblGrid>
              <a:tr h="373320">
                <a:tc rowSpan="2">
                  <a:txBody>
                    <a:bodyPr lIns="6480" rIns="6480" tIns="648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orbel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orbel"/>
                        </a:rPr>
                        <a:t>Nationalit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gridSpan="2">
                  <a:txBody>
                    <a:bodyPr lIns="65160" rIns="65160" tIns="32400" bIns="324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9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5160" marR="651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5160" rIns="65160" tIns="32400" bIns="324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9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5160" marR="651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5160" rIns="65160" tIns="32400" bIns="324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0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5160" marR="651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5160" rIns="65160" tIns="32400" bIns="324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0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5160" marR="651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41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orbel"/>
                        </a:rPr>
                        <a:t>Numbe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orbel"/>
                        </a:rPr>
                        <a:t>% of tota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orbel"/>
                        </a:rPr>
                        <a:t>Numbe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orbel"/>
                        </a:rPr>
                        <a:t>% of tota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orbel"/>
                        </a:rPr>
                        <a:t>Numbe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orbel"/>
                        </a:rPr>
                        <a:t>% of tota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orbel"/>
                        </a:rPr>
                        <a:t>Numbe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orbel"/>
                        </a:rPr>
                        <a:t>% of tota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</a:tr>
              <a:tr h="365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ines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15840" bIns="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15840" bIns="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15840" bIns="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15840" bIns="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15840" bIns="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15840" bIns="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15840" bIns="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15840" bIns="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484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lace of domicile - Hong Kon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 191 54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4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 623 46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0.4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 261 86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3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 374 2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2.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41472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lace of domicile - other than Hong Kon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8 02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4 71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6 89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6 06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48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lipino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4 65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0 73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9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3 66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5 34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484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donesia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.A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.A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 05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4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4 62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0 57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484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ritis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8 50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5 39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8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5 4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 99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48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dia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rowSpan="9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 32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rowSpan="9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rowSpan="9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 95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rowSpan="9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 48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 78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41472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kistani, Bangladeshi and Sri-Lanka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 16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 18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484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ha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 78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 99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 79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 15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48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epales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.A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.A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.A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.A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 37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 84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484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Japanes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85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 0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 71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 88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484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merica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 38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 94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 37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 60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487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nadia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 13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2 51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 86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 97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484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ther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9 06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3 77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5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9 15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1 72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412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ota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 522 28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 217 55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vMerge="1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.0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 708 38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.0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 864 34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.0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</a:tr>
            </a:tbl>
          </a:graphicData>
        </a:graphic>
      </p:graphicFrame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"/>
          <p:cNvGraphicFramePr/>
          <p:nvPr/>
        </p:nvGraphicFramePr>
        <p:xfrm>
          <a:off x="871560" y="1306440"/>
          <a:ext cx="7674120" cy="4897440"/>
        </p:xfrm>
        <a:graphic>
          <a:graphicData uri="http://schemas.openxmlformats.org/drawingml/2006/table">
            <a:tbl>
              <a:tblPr/>
              <a:tblGrid>
                <a:gridCol w="1330200"/>
                <a:gridCol w="849240"/>
                <a:gridCol w="763920"/>
                <a:gridCol w="806400"/>
                <a:gridCol w="806400"/>
                <a:gridCol w="779400"/>
                <a:gridCol w="779400"/>
                <a:gridCol w="779400"/>
                <a:gridCol w="779760"/>
              </a:tblGrid>
              <a:tr h="683640">
                <a:tc rowSpan="2"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alendar Year</a:t>
                      </a: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65160" rIns="65160" tIns="32400" bIns="324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Hong Kong</a:t>
                      </a:r>
                      <a:r>
                        <a:rPr b="1" lang="en-US" sz="1400" spc="-1" strike="noStrike">
                          <a:solidFill>
                            <a:srgbClr val="fac09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5160" marR="651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hina (other than Hong Kong)</a:t>
                      </a: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Elsewhere</a:t>
                      </a: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Total</a:t>
                      </a: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47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Numbe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% of total</a:t>
                      </a:r>
                      <a:r>
                        <a:rPr b="1" lang="en-US" sz="1400" spc="-1" strike="noStrike">
                          <a:solidFill>
                            <a:srgbClr val="376092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Numbe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% of total</a:t>
                      </a:r>
                      <a:r>
                        <a:rPr b="1" lang="en-US" sz="1400" spc="-1" strike="noStrike">
                          <a:solidFill>
                            <a:srgbClr val="376092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Numbe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% of total</a:t>
                      </a:r>
                      <a:r>
                        <a:rPr b="1" lang="en-US" sz="1400" spc="-1" strike="noStrike">
                          <a:solidFill>
                            <a:srgbClr val="376092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Numbe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% of total</a:t>
                      </a:r>
                      <a:r>
                        <a:rPr b="1" lang="en-US" sz="1400" spc="-1" strike="noStrike">
                          <a:solidFill>
                            <a:srgbClr val="376092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620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961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 492 887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7.7</a:t>
                      </a:r>
                      <a:r>
                        <a:rPr b="1" lang="en-US" sz="1400" spc="-1" strike="noStrike">
                          <a:solidFill>
                            <a:srgbClr val="f1597a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 579 231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0.5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7 53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.8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 129 648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0.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2372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971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 218 91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6.4</a:t>
                      </a:r>
                      <a:r>
                        <a:rPr b="1" lang="en-US" sz="1400" spc="-1" strike="noStrike">
                          <a:solidFill>
                            <a:srgbClr val="f1597a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 637 84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1.6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79 88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.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 936 63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0.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2336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976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 541 73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8.9</a:t>
                      </a:r>
                      <a:r>
                        <a:rPr b="1" lang="en-US" sz="1400" spc="-1" strike="noStrike">
                          <a:solidFill>
                            <a:srgbClr val="f1597a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 663 40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8.6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7 58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.5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 312 71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0.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2372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981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 854 482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7.2</a:t>
                      </a:r>
                      <a:r>
                        <a:rPr b="1" lang="en-US" sz="1400" spc="-1" strike="noStrike">
                          <a:solidFill>
                            <a:srgbClr val="f1597a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 973 976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9.6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58 102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.2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 986 56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0.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2372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986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 203 165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9.4</a:t>
                      </a:r>
                      <a:r>
                        <a:rPr b="1" lang="en-US" sz="1400" spc="-1" strike="noStrike">
                          <a:solidFill>
                            <a:srgbClr val="f1597a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 999 185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7.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93 647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.6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 395 997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0.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2336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991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 299 597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9.8</a:t>
                      </a:r>
                      <a:r>
                        <a:rPr b="1" lang="en-US" sz="1400" spc="-1" strike="noStrike">
                          <a:solidFill>
                            <a:srgbClr val="f1597a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 967 508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5.6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55 176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.6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 522 281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0.0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2372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996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 749 332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0.3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 096 511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3.7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71 713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.0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 217 556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0.0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2336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001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 004 894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9.7</a:t>
                      </a:r>
                      <a:r>
                        <a:rPr b="1" lang="en-US" sz="1400" spc="-1" strike="noStrike">
                          <a:solidFill>
                            <a:srgbClr val="f1597a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 263 571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3.7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39 924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.6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 708 389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0.0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2552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006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 138 844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0.3</a:t>
                      </a:r>
                      <a:r>
                        <a:rPr b="1" lang="en-US" sz="1400" spc="-1" strike="noStrike">
                          <a:solidFill>
                            <a:srgbClr val="f1597a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 298 956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3.5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426 546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.2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6 864 346</a:t>
                      </a:r>
                      <a:r>
                        <a:rPr b="1" lang="en-US" sz="1400" spc="-1" strike="noStrike">
                          <a:solidFill>
                            <a:srgbClr val="31859c"/>
                          </a:solidFill>
                          <a:latin typeface="Calibri"/>
                          <a:ea typeface="Times New Roman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00.0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7" name=""/>
          <p:cNvSpPr/>
          <p:nvPr/>
        </p:nvSpPr>
        <p:spPr>
          <a:xfrm>
            <a:off x="2462400" y="701640"/>
            <a:ext cx="458892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PMingLiU"/>
              </a:rPr>
              <a:t>Table S3 Population by place of birth in Hong Kong 1961-200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dcterms:modified xsi:type="dcterms:W3CDTF">2013-06-04T23:51:07Z</dcterms:modified>
  <cp:revision>0</cp:revision>
  <dc:subject/>
  <dc:title/>
</cp:coreProperties>
</file>